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56" d="100"/>
          <a:sy n="56" d="100"/>
        </p:scale>
        <p:origin x="10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4CA179-BB97-41B4-B741-9E895C81E6C9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A7990C-04D9-4AF6-A7B8-073A3EF396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87594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067A35-0CCD-7042-839E-B9971C50DAFD}" type="slidenum">
              <a:rPr lang="en-IT" smtClean="0"/>
              <a:t>1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2621872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131B70A-E0A8-3F05-C9FA-2AE9C7A6A8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0F8E5444-E0B6-21E0-85B0-67EA5FFA3A0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8DA9C89-3682-CE4E-3A6E-20D357B12F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CBADD-C9D3-4632-85F1-2294B025737F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79EC411-B6E0-F922-AA29-3D77E7755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55DF593-4C2E-633E-4E79-81642EC192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7DC9-4DE2-4B64-8B5E-F31C21276E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178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E6F2227-7384-594D-5FF1-B2EF4E9C1D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63335DA-A5CE-86D3-CCE0-618F6E1B49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0B97792-8B26-5E10-08D1-2CE6249AFE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CBADD-C9D3-4632-85F1-2294B025737F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2CC3D98-D3FD-34C4-CC0E-87860FA459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FD85CA5-5C13-E359-78A8-B53921C35B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7DC9-4DE2-4B64-8B5E-F31C21276E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1180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E30AFBC-0CDB-A367-14AC-B4D68D6CFA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48138D2-6493-A49B-355E-6C418E211D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8B09133-55A4-5472-FB99-75EBC3A05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CBADD-C9D3-4632-85F1-2294B025737F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2709CCE-0A8A-E6DF-BE59-C519A9836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1B4EEEC-56DD-4DAB-0DE3-2E0548A08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7DC9-4DE2-4B64-8B5E-F31C21276E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9688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9F66609-6CAC-80D6-0E7E-ACE4ECE154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F238D4A-05A9-02EA-B3BB-6F94E30586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5013F07-1826-C885-F5F9-9788F147C5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CBADD-C9D3-4632-85F1-2294B025737F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727B622-85C7-10D2-95F9-8EAAB6FEF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FFA8F41-BA4C-35FC-2566-95501E7BA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7DC9-4DE2-4B64-8B5E-F31C21276E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8910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C2EE8EA-26E9-A8BD-0625-4FB09C2D7E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3D86798-6E3F-781E-0840-D6E0745718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86A1A72-EC85-C359-72A8-748183E4FA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CBADD-C9D3-4632-85F1-2294B025737F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798F2EF-EE71-9AE8-7FB0-3BA1DEF78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B3C4C1A-9082-C0DF-DA00-701993A8DB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7DC9-4DE2-4B64-8B5E-F31C21276E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31209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ED06717-0194-1CCB-188F-BAA38DC50F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B80308F-9779-8C69-5787-56343A7E7F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259CF70-4C8E-93F5-CB8C-2C91C84698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885A95D-AFAB-4F30-BAEB-81ECF300C5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CBADD-C9D3-4632-85F1-2294B025737F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B6EB613-FA86-AF09-D610-10A26FB6F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AFD1C9E-10AA-3E78-2CFF-755420797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7DC9-4DE2-4B64-8B5E-F31C21276E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60975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4526079-A770-8255-2DDC-0C6B8C9283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B6C4925-458D-BBA3-9E67-F5255521B9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9936298-DE47-0B83-71CB-C571AA7C45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2F5AC8E-65ED-47E9-3238-310B3D3479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1E358BCD-122A-F54C-28D2-6668E827B6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D765E17-DE40-5F19-2797-AF1F22998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CBADD-C9D3-4632-85F1-2294B025737F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5E3F1B5B-6E8B-92F4-C862-F75D1D8F8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297596D4-B3DC-75A6-2FBC-8E5E6F40B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7DC9-4DE2-4B64-8B5E-F31C21276E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8174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1E57140-98BD-D528-B305-7AB6F3A514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A457B08-17A9-788F-E36B-86F122130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CBADD-C9D3-4632-85F1-2294B025737F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52F9C7FA-056C-541B-8B5D-7D855ADE4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243B3FDA-2F01-5C36-DAD4-E749388632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7DC9-4DE2-4B64-8B5E-F31C21276E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2387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9A105C9-D174-54F7-EAF6-8C381EB5A8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CBADD-C9D3-4632-85F1-2294B025737F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C01FE24-6555-7BE5-0873-6DC718787B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01AF3B3-A737-F2E2-4E28-B5EC3FD2AE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7DC9-4DE2-4B64-8B5E-F31C21276E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958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5DED0D7-A5BA-D2AB-718E-B303D17916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FFCFD6F-A096-DCC9-FD2F-D168B1CCDE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30DAAD8-2B95-DA80-7062-8E7017595D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13A4DCA-E937-60EB-472A-7F7664E5B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CBADD-C9D3-4632-85F1-2294B025737F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85A70FF-DF1F-0727-F33B-117D1B667B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FA9994F-92CC-193B-FDC9-6A03C5E04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7DC9-4DE2-4B64-8B5E-F31C21276E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2490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15428BD-A2ED-3AC5-8AEA-71B27727E1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BF82CCF-A034-626D-C95C-B320EAC739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0500CC6-50C8-EB00-E16B-59B9DFB754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1F228BE-849C-75D9-4309-2E9E83602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CBADD-C9D3-4632-85F1-2294B025737F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C1CBBBC-A514-9C3A-627E-69B57646C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0564CC3-B0D8-F89E-005A-EAA3C23403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E7DC9-4DE2-4B64-8B5E-F31C21276E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8598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C461D7F6-4A96-EAAE-3DCD-DF698A06A0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FF14093-61FA-0B3F-AF09-76E48589F9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81D2818-059C-BD5C-E9C0-0752E6AABB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CBADD-C9D3-4632-85F1-2294B025737F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45028BC-3217-7A6E-435F-273C6B0002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321906D-9BEA-F69C-1931-16374B8F2F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6E7DC9-4DE2-4B64-8B5E-F31C21276E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2422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249AAB0-D3C3-A9A0-71AF-EE083BECE97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A5D9965-2340-49EF-58EC-1CF02D9DEA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92055" y="1214862"/>
            <a:ext cx="2918984" cy="291898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F0D0EF7-4F3C-FFE5-AAB1-55B19256031E}"/>
              </a:ext>
            </a:extLst>
          </p:cNvPr>
          <p:cNvSpPr txBox="1"/>
          <p:nvPr/>
        </p:nvSpPr>
        <p:spPr>
          <a:xfrm>
            <a:off x="2400299" y="281354"/>
            <a:ext cx="70122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dirty="0"/>
              <a:t>Supplemental Figure 2: Disease Free Survival curves in the INT cohort (A) and in the STRASS cohort (B) according to CINSAR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CCBF40B-1FEA-12D2-E82B-4F708A8DB497}"/>
              </a:ext>
            </a:extLst>
          </p:cNvPr>
          <p:cNvSpPr txBox="1"/>
          <p:nvPr/>
        </p:nvSpPr>
        <p:spPr>
          <a:xfrm>
            <a:off x="2400299" y="103163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48C65C3-47A8-4601-73EC-28A0A2760E7B}"/>
              </a:ext>
            </a:extLst>
          </p:cNvPr>
          <p:cNvSpPr txBox="1"/>
          <p:nvPr/>
        </p:nvSpPr>
        <p:spPr>
          <a:xfrm>
            <a:off x="6274777" y="103163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B</a:t>
            </a:r>
          </a:p>
        </p:txBody>
      </p:sp>
      <p:pic>
        <p:nvPicPr>
          <p:cNvPr id="11" name="Immagine 10" descr="Immagine che contiene testo, schermata, diagramma, linea&#10;&#10;Descrizione generata automaticamente">
            <a:extLst>
              <a:ext uri="{FF2B5EF4-FFF2-40B4-BE49-F238E27FC236}">
                <a16:creationId xmlns:a16="http://schemas.microsoft.com/office/drawing/2014/main" id="{C65586D6-E3B9-4D86-F2A1-DB0B4E7C8D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80961" y="1214862"/>
            <a:ext cx="3077363" cy="3077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06871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asquali Sandro</dc:creator>
  <cp:lastModifiedBy>Pasquali Sandro</cp:lastModifiedBy>
  <cp:revision>1</cp:revision>
  <dcterms:created xsi:type="dcterms:W3CDTF">2025-05-21T11:08:33Z</dcterms:created>
  <dcterms:modified xsi:type="dcterms:W3CDTF">2025-05-21T11:08:58Z</dcterms:modified>
</cp:coreProperties>
</file>